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3CB2C-6B47-4532-9F0F-160E791337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5D25A-D9A3-4B73-858D-1772314069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3967D-4F9A-4EDF-9C49-95BF0120A6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716B9-B472-4C1B-B004-49640FCCC9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D9C69-75C8-45CA-8B33-D371590DBA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F92F3-D771-402E-86C9-19D3753D43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7F650-9B49-45F1-BF27-F38A2484EA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35D95-3084-48EF-9A66-0A51BF1460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62D8B-EC2A-4963-B656-4944039E09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CF07A-0E5E-464F-A5CD-8A950891EE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0EC95-C07C-4FB6-8DD3-AC421DD99F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DDE13-BB3A-480A-A9CD-2C47CB06FD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D8CB8B-82D6-4E3C-94FC-7DB1E337990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429000" y="350532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430440" y="152388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438280" y="2743200"/>
            <a:ext cx="121932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70000"/>
          </a:bodyPr>
          <a:p>
            <a:pPr marL="240120" indent="-240120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Arial"/>
              </a:rPr>
              <a:t>Esterase B</a:t>
            </a:r>
            <a:r>
              <a:rPr b="0" lang="fr-FR" sz="1400" spc="-1" strike="noStrike" baseline="-25000">
                <a:solidFill>
                  <a:srgbClr val="000000"/>
                </a:solidFill>
                <a:latin typeface="Times New Roman"/>
                <a:ea typeface="Arial"/>
              </a:rPr>
              <a:t>1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Arial"/>
              </a:rPr>
              <a:t> (Mf 7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562720" y="2743200"/>
            <a:ext cx="129528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79000"/>
          </a:bodyPr>
          <a:p>
            <a:pPr marL="270720" indent="-270720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Arial"/>
              </a:rPr>
              <a:t>Esterase B</a:t>
            </a:r>
            <a:r>
              <a:rPr b="0" lang="fr-FR" sz="1400" spc="-1" strike="noStrike" baseline="-25000">
                <a:solidFill>
                  <a:srgbClr val="000000"/>
                </a:solidFill>
                <a:latin typeface="Times New Roman"/>
                <a:ea typeface="Arial"/>
              </a:rPr>
              <a:t>1</a:t>
            </a:r>
            <a:r>
              <a:rPr b="0" lang="fr-FR" sz="1400" spc="-1" strike="noStrike">
                <a:solidFill>
                  <a:srgbClr val="000000"/>
                </a:solidFill>
                <a:latin typeface="Times New Roman"/>
                <a:ea typeface="Arial"/>
              </a:rPr>
              <a:t> (Mf 7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438280" y="3146400"/>
            <a:ext cx="106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Esterase 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963600" y="11541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477680" y="11541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011200" y="11541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860880" y="5945040"/>
            <a:ext cx="1886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Times New Roman"/>
              </a:rPr>
              <a:t>Additionnal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3751200" y="1628640"/>
            <a:ext cx="1658880" cy="2105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1905120" y="1231920"/>
            <a:ext cx="5452920" cy="387360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6860880" y="5945040"/>
            <a:ext cx="1886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Times New Roman"/>
              </a:rPr>
              <a:t>Additionnal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338720" y="4605480"/>
            <a:ext cx="7171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ime (h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1823040" y="1413000"/>
            <a:ext cx="362880" cy="223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umulative survey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144520" y="4048200"/>
            <a:ext cx="2448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066400" y="2997360"/>
            <a:ext cx="340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079000" y="2492280"/>
            <a:ext cx="340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060640" y="1989000"/>
            <a:ext cx="342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135160" y="1484280"/>
            <a:ext cx="2448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103480" y="2233440"/>
            <a:ext cx="183960" cy="2145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979640" y="3646440"/>
            <a:ext cx="183960" cy="214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079000" y="3544920"/>
            <a:ext cx="340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525400" y="4408560"/>
            <a:ext cx="2448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006000" y="4408560"/>
            <a:ext cx="340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524040" y="4408560"/>
            <a:ext cx="2448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975840" y="4408560"/>
            <a:ext cx="340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477680" y="4408560"/>
            <a:ext cx="308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920480" y="4408560"/>
            <a:ext cx="4046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447880" y="4408560"/>
            <a:ext cx="308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895000" y="4408560"/>
            <a:ext cx="4046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7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422400" y="4408560"/>
            <a:ext cx="308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133720" y="2666880"/>
            <a:ext cx="22860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133720" y="2209680"/>
            <a:ext cx="22860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133720" y="3200400"/>
            <a:ext cx="22860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u722</cp:lastModifiedBy>
  <dcterms:modified xsi:type="dcterms:W3CDTF">2009-09-04T09:06:21Z</dcterms:modified>
  <cp:revision>1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